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2102" y="-3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8CCCE-E698-4E7F-947B-BD149F05D9E8}" type="datetimeFigureOut">
              <a:rPr lang="zh-CN" altLang="en-US" smtClean="0"/>
              <a:pPr/>
              <a:t>2014/1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017B-5BD1-42A2-90F6-B6EDD69CB5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48138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8CCCE-E698-4E7F-947B-BD149F05D9E8}" type="datetimeFigureOut">
              <a:rPr lang="zh-CN" altLang="en-US" smtClean="0"/>
              <a:pPr/>
              <a:t>2014/1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017B-5BD1-42A2-90F6-B6EDD69CB5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03507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8CCCE-E698-4E7F-947B-BD149F05D9E8}" type="datetimeFigureOut">
              <a:rPr lang="zh-CN" altLang="en-US" smtClean="0"/>
              <a:pPr/>
              <a:t>2014/1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017B-5BD1-42A2-90F6-B6EDD69CB5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2776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8CCCE-E698-4E7F-947B-BD149F05D9E8}" type="datetimeFigureOut">
              <a:rPr lang="zh-CN" altLang="en-US" smtClean="0"/>
              <a:pPr/>
              <a:t>2014/1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017B-5BD1-42A2-90F6-B6EDD69CB5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8500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8CCCE-E698-4E7F-947B-BD149F05D9E8}" type="datetimeFigureOut">
              <a:rPr lang="zh-CN" altLang="en-US" smtClean="0"/>
              <a:pPr/>
              <a:t>2014/1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017B-5BD1-42A2-90F6-B6EDD69CB5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95576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8CCCE-E698-4E7F-947B-BD149F05D9E8}" type="datetimeFigureOut">
              <a:rPr lang="zh-CN" altLang="en-US" smtClean="0"/>
              <a:pPr/>
              <a:t>2014/1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017B-5BD1-42A2-90F6-B6EDD69CB5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6397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8CCCE-E698-4E7F-947B-BD149F05D9E8}" type="datetimeFigureOut">
              <a:rPr lang="zh-CN" altLang="en-US" smtClean="0"/>
              <a:pPr/>
              <a:t>2014/1/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017B-5BD1-42A2-90F6-B6EDD69CB5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87132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8CCCE-E698-4E7F-947B-BD149F05D9E8}" type="datetimeFigureOut">
              <a:rPr lang="zh-CN" altLang="en-US" smtClean="0"/>
              <a:pPr/>
              <a:t>2014/1/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017B-5BD1-42A2-90F6-B6EDD69CB5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7015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8CCCE-E698-4E7F-947B-BD149F05D9E8}" type="datetimeFigureOut">
              <a:rPr lang="zh-CN" altLang="en-US" smtClean="0"/>
              <a:pPr/>
              <a:t>2014/1/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017B-5BD1-42A2-90F6-B6EDD69CB5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3572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8CCCE-E698-4E7F-947B-BD149F05D9E8}" type="datetimeFigureOut">
              <a:rPr lang="zh-CN" altLang="en-US" smtClean="0"/>
              <a:pPr/>
              <a:t>2014/1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017B-5BD1-42A2-90F6-B6EDD69CB5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3636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98CCCE-E698-4E7F-947B-BD149F05D9E8}" type="datetimeFigureOut">
              <a:rPr lang="zh-CN" altLang="en-US" smtClean="0"/>
              <a:pPr/>
              <a:t>2014/1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3F017B-5BD1-42A2-90F6-B6EDD69CB5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86160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98CCCE-E698-4E7F-947B-BD149F05D9E8}" type="datetimeFigureOut">
              <a:rPr lang="zh-CN" altLang="en-US" smtClean="0"/>
              <a:pPr/>
              <a:t>2014/1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3F017B-5BD1-42A2-90F6-B6EDD69CB5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5048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0" y="0"/>
            <a:ext cx="3429000" cy="338554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Picture 2" descr="J:\HK data\pulmonary artery mophometric analysis\weigert stain lyh\CH.jpg"/>
          <p:cNvPicPr>
            <a:picLocks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76" t="11881" r="24256" b="17382"/>
          <a:stretch/>
        </p:blipFill>
        <p:spPr bwMode="auto">
          <a:xfrm>
            <a:off x="3389426" y="2643084"/>
            <a:ext cx="2124000" cy="2124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4" descr="J:\HK data\pulmonary artery mophometric analysis\200511\ctrl\2.jpg"/>
          <p:cNvPicPr>
            <a:picLocks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25000"/>
                    </a14:imgEffect>
                    <a14:imgEffect>
                      <a14:colorTemperature colorTemp="112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292" t="26237" r="24866" b="16500"/>
          <a:stretch/>
        </p:blipFill>
        <p:spPr bwMode="auto">
          <a:xfrm>
            <a:off x="1208722" y="2643084"/>
            <a:ext cx="2124000" cy="2124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1622650" y="2181438"/>
            <a:ext cx="12961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moxi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803354" y="2181438"/>
            <a:ext cx="12961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46"/>
          <p:cNvSpPr>
            <a:spLocks noChangeArrowheads="1"/>
          </p:cNvSpPr>
          <p:nvPr/>
        </p:nvSpPr>
        <p:spPr bwMode="auto">
          <a:xfrm>
            <a:off x="392906" y="5024006"/>
            <a:ext cx="6072187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just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1. Vascular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modeling in rats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lmonary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terial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pertension (PAH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igert’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lastic staining revealed medial thickening changes in lungs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CH,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ronically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poxi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2483112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7"/>
          <p:cNvPicPr>
            <a:picLocks noChangeArrowheads="1"/>
          </p:cNvPicPr>
          <p:nvPr/>
        </p:nvPicPr>
        <p:blipFill>
          <a:blip r:embed="rId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9404" y="2844801"/>
            <a:ext cx="2160587" cy="3063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8"/>
          <p:cNvPicPr>
            <a:picLocks noChangeArrowheads="1"/>
          </p:cNvPicPr>
          <p:nvPr/>
        </p:nvPicPr>
        <p:blipFill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6229" y="3209926"/>
            <a:ext cx="2160587" cy="30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2"/>
          <p:cNvSpPr txBox="1">
            <a:spLocks noChangeArrowheads="1"/>
          </p:cNvSpPr>
          <p:nvPr/>
        </p:nvSpPr>
        <p:spPr bwMode="auto">
          <a:xfrm>
            <a:off x="1599754" y="2849563"/>
            <a:ext cx="86360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algn="r" eaLnBrk="1" hangingPunct="1"/>
            <a:r>
              <a:rPr lang="en-US" altLang="zh-CN">
                <a:latin typeface="Arial" pitchFamily="34" charset="0"/>
                <a:cs typeface="Arial" pitchFamily="34" charset="0"/>
              </a:rPr>
              <a:t>ET</a:t>
            </a:r>
            <a:r>
              <a:rPr lang="en-US" altLang="zh-CN" baseline="-25000">
                <a:latin typeface="Arial" pitchFamily="34" charset="0"/>
                <a:cs typeface="Arial" pitchFamily="34" charset="0"/>
              </a:rPr>
              <a:t>A</a:t>
            </a:r>
            <a:r>
              <a:rPr lang="en-US" altLang="zh-CN">
                <a:latin typeface="Arial" pitchFamily="34" charset="0"/>
                <a:cs typeface="Arial" pitchFamily="34" charset="0"/>
              </a:rPr>
              <a:t>R</a:t>
            </a:r>
            <a:endParaRPr lang="zh-CN" alt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10"/>
          <p:cNvSpPr txBox="1">
            <a:spLocks noChangeArrowheads="1"/>
          </p:cNvSpPr>
          <p:nvPr/>
        </p:nvSpPr>
        <p:spPr bwMode="auto">
          <a:xfrm>
            <a:off x="1357298" y="3205163"/>
            <a:ext cx="111399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algn="r" eaLnBrk="1" hangingPunct="1"/>
            <a:r>
              <a:rPr lang="en-US" altLang="zh-CN" dirty="0">
                <a:latin typeface="Symbol" pitchFamily="18" charset="2"/>
                <a:cs typeface="Arial" pitchFamily="34" charset="0"/>
              </a:rPr>
              <a:t>b</a:t>
            </a:r>
            <a:r>
              <a:rPr lang="en-US" altLang="zh-CN" dirty="0">
                <a:latin typeface="Arial" pitchFamily="34" charset="0"/>
                <a:cs typeface="Arial" pitchFamily="34" charset="0"/>
              </a:rPr>
              <a:t>-actin</a:t>
            </a:r>
            <a:endParaRPr lang="zh-CN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2"/>
          <p:cNvSpPr txBox="1">
            <a:spLocks noChangeArrowheads="1"/>
          </p:cNvSpPr>
          <p:nvPr/>
        </p:nvSpPr>
        <p:spPr bwMode="auto">
          <a:xfrm rot="18900000">
            <a:off x="2209760" y="3696088"/>
            <a:ext cx="113347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600" dirty="0" err="1">
                <a:latin typeface="Arial" pitchFamily="34" charset="0"/>
                <a:cs typeface="Arial" pitchFamily="34" charset="0"/>
              </a:rPr>
              <a:t>Normoxia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2"/>
          <p:cNvSpPr txBox="1">
            <a:spLocks noChangeArrowheads="1"/>
          </p:cNvSpPr>
          <p:nvPr/>
        </p:nvSpPr>
        <p:spPr bwMode="auto">
          <a:xfrm rot="18900000">
            <a:off x="2924135" y="3686563"/>
            <a:ext cx="113347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600" dirty="0">
                <a:latin typeface="Arial" pitchFamily="34" charset="0"/>
                <a:cs typeface="Arial" pitchFamily="34" charset="0"/>
              </a:rPr>
              <a:t>CH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2"/>
          <p:cNvSpPr txBox="1">
            <a:spLocks noChangeArrowheads="1"/>
          </p:cNvSpPr>
          <p:nvPr/>
        </p:nvSpPr>
        <p:spPr bwMode="auto">
          <a:xfrm rot="18900000">
            <a:off x="3377584" y="3840086"/>
            <a:ext cx="143358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600" dirty="0">
                <a:latin typeface="Arial" pitchFamily="34" charset="0"/>
                <a:cs typeface="Arial" pitchFamily="34" charset="0"/>
              </a:rPr>
              <a:t>CH + RSG</a:t>
            </a:r>
            <a:endParaRPr lang="zh-CN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Rectangle 46"/>
          <p:cNvSpPr>
            <a:spLocks noChangeArrowheads="1"/>
          </p:cNvSpPr>
          <p:nvPr/>
        </p:nvSpPr>
        <p:spPr bwMode="auto">
          <a:xfrm>
            <a:off x="468834" y="4377675"/>
            <a:ext cx="6072187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1pPr>
            <a:lvl2pPr marL="742950" indent="-285750"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2pPr>
            <a:lvl3pPr marL="1143000" indent="-228600"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3pPr>
            <a:lvl4pPr marL="1600200" indent="-228600"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4pPr>
            <a:lvl5pPr marL="2057400" indent="-228600" eaLnBrk="0" hangingPunct="0"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charset="0"/>
                <a:ea typeface="宋体" pitchFamily="2" charset="-122"/>
              </a:defRPr>
            </a:lvl9pPr>
          </a:lstStyle>
          <a:p>
            <a:pPr algn="just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2. Rosiglitazone inhibited ET</a:t>
            </a:r>
            <a:r>
              <a:rPr lang="en-US" altLang="zh-CN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 expression in rats for PAH. Western blot analyses of protein levels of ET</a:t>
            </a:r>
            <a:r>
              <a:rPr lang="en-US" altLang="zh-CN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 in rat pulmonary arteries. CH, chronically hypoxic. RSG, rosiglitazone.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0" y="0"/>
            <a:ext cx="3429000" cy="338554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57486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3</TotalTime>
  <Words>80</Words>
  <Application>Microsoft Office PowerPoint</Application>
  <PresentationFormat>全屏显示(4:3)</PresentationFormat>
  <Paragraphs>11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35</cp:revision>
  <dcterms:created xsi:type="dcterms:W3CDTF">2013-12-09T12:54:22Z</dcterms:created>
  <dcterms:modified xsi:type="dcterms:W3CDTF">2014-01-03T02:56:45Z</dcterms:modified>
</cp:coreProperties>
</file>